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C6FE9E-7716-4A37-8973-8ED42C229D2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33280A-4CE0-47C8-9DEE-12DA9E24B8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9357E4-CB17-43E6-B825-6541CB2CC48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5BD3D9-CD3C-4F9D-A33A-8D7494E3C8C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0E2C52-59FF-4C64-876C-140EF5CFAB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85F8E2-6A72-443F-B38D-CDC2BBC359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79B594-57AB-41E0-80BB-A46644ACD1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75421B-F3A1-4827-A2AA-F5AD2EFAA89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E21256-5C26-44EF-9AA3-1F52909E82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AA8C84-87F8-4FAC-BEC7-59D2C04DDE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FBC1E8-2A0D-4D44-A65B-E0BE39DE5C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FD8533-04A7-4778-BE93-3ED4195268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F9E3859-770C-4AF2-AB39-791BBCDC333A}" type="slidenum">
              <a:rPr b="0" lang="es-E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2"/>
          <p:cNvGrpSpPr/>
          <p:nvPr/>
        </p:nvGrpSpPr>
        <p:grpSpPr>
          <a:xfrm>
            <a:off x="3203640" y="1413000"/>
            <a:ext cx="2305080" cy="3960720"/>
            <a:chOff x="3203640" y="1413000"/>
            <a:chExt cx="2305080" cy="3960720"/>
          </a:xfrm>
        </p:grpSpPr>
        <p:pic>
          <p:nvPicPr>
            <p:cNvPr id="42" name="Picture 4" descr="rna"/>
            <p:cNvPicPr/>
            <p:nvPr/>
          </p:nvPicPr>
          <p:blipFill>
            <a:blip r:embed="rId1"/>
            <a:srcRect l="40683" t="23764" r="26696" b="0"/>
            <a:stretch/>
          </p:blipFill>
          <p:spPr>
            <a:xfrm>
              <a:off x="3203640" y="1413000"/>
              <a:ext cx="2305080" cy="3960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Text Box 5"/>
            <p:cNvSpPr/>
            <p:nvPr/>
          </p:nvSpPr>
          <p:spPr>
            <a:xfrm>
              <a:off x="4643280" y="3213000"/>
              <a:ext cx="571680" cy="34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ffffff"/>
                  </a:solidFill>
                  <a:latin typeface="Times New Roman"/>
                </a:rPr>
                <a:t>28 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 Box 6"/>
            <p:cNvSpPr/>
            <p:nvPr/>
          </p:nvSpPr>
          <p:spPr>
            <a:xfrm>
              <a:off x="4572000" y="4005360"/>
              <a:ext cx="800280" cy="342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ffffff"/>
                  </a:solidFill>
                  <a:latin typeface="Times New Roman"/>
                </a:rPr>
                <a:t>  </a:t>
              </a:r>
              <a:r>
                <a:rPr b="1" lang="en-US" sz="1400" spc="-1" strike="noStrike">
                  <a:solidFill>
                    <a:srgbClr val="ffffff"/>
                  </a:solidFill>
                  <a:latin typeface="Times New Roman"/>
                </a:rPr>
                <a:t>18 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AutoShape 7"/>
            <p:cNvSpPr/>
            <p:nvPr/>
          </p:nvSpPr>
          <p:spPr>
            <a:xfrm>
              <a:off x="4284720" y="3284640"/>
              <a:ext cx="360360" cy="144360"/>
            </a:xfrm>
            <a:prstGeom prst="leftArrow">
              <a:avLst>
                <a:gd name="adj1" fmla="val 50000"/>
                <a:gd name="adj2" fmla="val 62406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560" bIns="2556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AutoShape 8"/>
            <p:cNvSpPr/>
            <p:nvPr/>
          </p:nvSpPr>
          <p:spPr>
            <a:xfrm>
              <a:off x="4284720" y="4076640"/>
              <a:ext cx="360360" cy="144360"/>
            </a:xfrm>
            <a:prstGeom prst="leftArrow">
              <a:avLst>
                <a:gd name="adj1" fmla="val 50000"/>
                <a:gd name="adj2" fmla="val 62406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560" bIns="2556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7" name="Text Box 13"/>
          <p:cNvSpPr/>
          <p:nvPr/>
        </p:nvSpPr>
        <p:spPr>
          <a:xfrm>
            <a:off x="1023840" y="500040"/>
            <a:ext cx="73645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Figure S2:</a:t>
            </a:r>
            <a:r>
              <a:rPr b="0" lang="es-E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s-ES_tradnl" sz="1200" spc="-1" strike="noStrike">
                <a:solidFill>
                  <a:srgbClr val="000000"/>
                </a:solidFill>
                <a:latin typeface="Arial"/>
              </a:rPr>
              <a:t>Representative image of a denaturing agarose gel to check RNA integrity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Two bright bands corresponding to ribosomal 28S rRNA and 18S rRNA are observe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1-13T11:10:21Z</dcterms:created>
  <dc:creator>laboratorio</dc:creator>
  <dc:description/>
  <dc:language>en-US</dc:language>
  <cp:lastModifiedBy>laboratorio</cp:lastModifiedBy>
  <dcterms:modified xsi:type="dcterms:W3CDTF">2013-12-09T11:46:57Z</dcterms:modified>
  <cp:revision>9</cp:revision>
  <dc:subject/>
  <dc:title>Diapositiva 1</dc:title>
</cp:coreProperties>
</file>